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07" r:id="rId2"/>
    <p:sldId id="312" r:id="rId3"/>
  </p:sldIdLst>
  <p:sldSz cx="6858000" cy="9144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CC33"/>
    <a:srgbClr val="FF00FF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891" autoAdjust="0"/>
    <p:restoredTop sz="95394" autoAdjust="0"/>
  </p:normalViewPr>
  <p:slideViewPr>
    <p:cSldViewPr snapToGrid="0">
      <p:cViewPr varScale="1">
        <p:scale>
          <a:sx n="67" d="100"/>
          <a:sy n="67" d="100"/>
        </p:scale>
        <p:origin x="2098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nalysis!$I$71:$R$71</c:f>
                <c:numCache>
                  <c:formatCode>General</c:formatCode>
                  <c:ptCount val="10"/>
                  <c:pt idx="0">
                    <c:v>0.10033627548057104</c:v>
                  </c:pt>
                  <c:pt idx="1">
                    <c:v>0.62488263644721587</c:v>
                  </c:pt>
                  <c:pt idx="2">
                    <c:v>1.3900180191582261</c:v>
                  </c:pt>
                  <c:pt idx="3">
                    <c:v>0.36224573049370673</c:v>
                  </c:pt>
                  <c:pt idx="4">
                    <c:v>0.51921061565788584</c:v>
                  </c:pt>
                  <c:pt idx="5">
                    <c:v>4.0135354334472462</c:v>
                  </c:pt>
                  <c:pt idx="6">
                    <c:v>4.3064739888750978</c:v>
                  </c:pt>
                  <c:pt idx="7">
                    <c:v>3.1537176144592669</c:v>
                  </c:pt>
                  <c:pt idx="8">
                    <c:v>0.28634707620656863</c:v>
                  </c:pt>
                  <c:pt idx="9">
                    <c:v>0.403198735807927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I$46:$R$46</c:f>
              <c:strCache>
                <c:ptCount val="10"/>
                <c:pt idx="0">
                  <c:v>0 min</c:v>
                </c:pt>
                <c:pt idx="1">
                  <c:v>5 min</c:v>
                </c:pt>
                <c:pt idx="2">
                  <c:v>15 min</c:v>
                </c:pt>
                <c:pt idx="3">
                  <c:v>30 min</c:v>
                </c:pt>
                <c:pt idx="4">
                  <c:v>60 min</c:v>
                </c:pt>
                <c:pt idx="5">
                  <c:v>120 min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analysis!$I$69:$R$69</c:f>
              <c:numCache>
                <c:formatCode>General</c:formatCode>
                <c:ptCount val="10"/>
                <c:pt idx="0">
                  <c:v>2.934610639771531</c:v>
                </c:pt>
                <c:pt idx="1">
                  <c:v>7.1650634533341089</c:v>
                </c:pt>
                <c:pt idx="2">
                  <c:v>18.169789261811299</c:v>
                </c:pt>
                <c:pt idx="3">
                  <c:v>16.126109171749018</c:v>
                </c:pt>
                <c:pt idx="4">
                  <c:v>19.789690825863513</c:v>
                </c:pt>
                <c:pt idx="5">
                  <c:v>41.029115994551482</c:v>
                </c:pt>
                <c:pt idx="6">
                  <c:v>41.656916432801815</c:v>
                </c:pt>
                <c:pt idx="7">
                  <c:v>25.62780574004854</c:v>
                </c:pt>
                <c:pt idx="8">
                  <c:v>18.758987323533194</c:v>
                </c:pt>
                <c:pt idx="9">
                  <c:v>14.6171175214593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255593336"/>
        <c:axId val="255597648"/>
      </c:barChart>
      <c:catAx>
        <c:axId val="255593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55597648"/>
        <c:crosses val="autoZero"/>
        <c:auto val="1"/>
        <c:lblAlgn val="ctr"/>
        <c:lblOffset val="100"/>
        <c:noMultiLvlLbl val="0"/>
      </c:catAx>
      <c:valAx>
        <c:axId val="255597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AMP concentration (pmol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55593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nalysis!$V$71:$AE$71</c:f>
                <c:numCache>
                  <c:formatCode>General</c:formatCode>
                  <c:ptCount val="10"/>
                  <c:pt idx="0">
                    <c:v>0.75759663981153336</c:v>
                  </c:pt>
                  <c:pt idx="1">
                    <c:v>0.15265284119101025</c:v>
                  </c:pt>
                  <c:pt idx="2">
                    <c:v>8.4772000744931145E-2</c:v>
                  </c:pt>
                  <c:pt idx="3">
                    <c:v>0.70500966861209602</c:v>
                  </c:pt>
                  <c:pt idx="4">
                    <c:v>0.68837522939930551</c:v>
                  </c:pt>
                  <c:pt idx="5">
                    <c:v>2.1436821637317651</c:v>
                  </c:pt>
                  <c:pt idx="6">
                    <c:v>7.3134652612952848</c:v>
                  </c:pt>
                  <c:pt idx="7">
                    <c:v>0.54261207368939579</c:v>
                  </c:pt>
                  <c:pt idx="8">
                    <c:v>1.2640330334874175</c:v>
                  </c:pt>
                  <c:pt idx="9">
                    <c:v>0.45885104132951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sis!$I$46:$R$46</c:f>
              <c:strCache>
                <c:ptCount val="10"/>
                <c:pt idx="0">
                  <c:v>0 min</c:v>
                </c:pt>
                <c:pt idx="1">
                  <c:v>5 min</c:v>
                </c:pt>
                <c:pt idx="2">
                  <c:v>15 min</c:v>
                </c:pt>
                <c:pt idx="3">
                  <c:v>30 min</c:v>
                </c:pt>
                <c:pt idx="4">
                  <c:v>60 min</c:v>
                </c:pt>
                <c:pt idx="5">
                  <c:v>120 min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analysis!$V$69:$AE$69</c:f>
              <c:numCache>
                <c:formatCode>General</c:formatCode>
                <c:ptCount val="10"/>
                <c:pt idx="0">
                  <c:v>2.1867342099757443</c:v>
                </c:pt>
                <c:pt idx="1">
                  <c:v>2.0182996457099809</c:v>
                </c:pt>
                <c:pt idx="2">
                  <c:v>3.5195885998893282</c:v>
                </c:pt>
                <c:pt idx="3">
                  <c:v>5.9015758043739268</c:v>
                </c:pt>
                <c:pt idx="4">
                  <c:v>9.7683776587761297</c:v>
                </c:pt>
                <c:pt idx="5">
                  <c:v>15.112612342366413</c:v>
                </c:pt>
                <c:pt idx="6">
                  <c:v>19.836250521025896</c:v>
                </c:pt>
                <c:pt idx="7">
                  <c:v>10.916653003120182</c:v>
                </c:pt>
                <c:pt idx="8">
                  <c:v>8.3217918382774201</c:v>
                </c:pt>
                <c:pt idx="9">
                  <c:v>4.72141065044708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255594120"/>
        <c:axId val="255594904"/>
      </c:barChart>
      <c:catAx>
        <c:axId val="255594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55594904"/>
        <c:crosses val="autoZero"/>
        <c:auto val="1"/>
        <c:lblAlgn val="ctr"/>
        <c:lblOffset val="100"/>
        <c:noMultiLvlLbl val="0"/>
      </c:catAx>
      <c:valAx>
        <c:axId val="2555949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AMP concentration (pmol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55594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r">
              <a:defRPr sz="1200"/>
            </a:lvl1pPr>
          </a:lstStyle>
          <a:p>
            <a:fld id="{F55F39D5-FBF2-4E03-B860-D6061CEA40EE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3" tIns="45708" rIns="91413" bIns="45708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40" y="4621213"/>
            <a:ext cx="5851525" cy="3779837"/>
          </a:xfrm>
          <a:prstGeom prst="rect">
            <a:avLst/>
          </a:prstGeom>
        </p:spPr>
        <p:txBody>
          <a:bodyPr vert="horz" lIns="91413" tIns="45708" rIns="91413" bIns="4570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r">
              <a:defRPr sz="1200"/>
            </a:lvl1pPr>
          </a:lstStyle>
          <a:p>
            <a:fld id="{A3AF5CD0-6BC9-430B-B562-288C9451AB4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907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820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72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4799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562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15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11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667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68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80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62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28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28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oleObject" Target="../embeddings/oleObject5.bin"/><Relationship Id="rId3" Type="http://schemas.openxmlformats.org/officeDocument/2006/relationships/chart" Target="../charts/chart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10" Type="http://schemas.openxmlformats.org/officeDocument/2006/relationships/image" Target="../media/image3.emf"/><Relationship Id="rId4" Type="http://schemas.openxmlformats.org/officeDocument/2006/relationships/chart" Target="../charts/chart2.xml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980678" y="1031521"/>
            <a:ext cx="4896645" cy="7080959"/>
            <a:chOff x="727251" y="304766"/>
            <a:chExt cx="4896645" cy="7080959"/>
          </a:xfrm>
        </p:grpSpPr>
        <p:sp>
          <p:nvSpPr>
            <p:cNvPr id="4" name="TextBox 3"/>
            <p:cNvSpPr txBox="1"/>
            <p:nvPr/>
          </p:nvSpPr>
          <p:spPr>
            <a:xfrm>
              <a:off x="4501852" y="627869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99829" y="2156270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99829" y="3729213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980541" y="621775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980542" y="2156270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80542" y="3741280"/>
              <a:ext cx="5623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aphicFrame>
          <p:nvGraphicFramePr>
            <p:cNvPr id="25" name="Chart 24"/>
            <p:cNvGraphicFramePr>
              <a:graphicFrameLocks/>
            </p:cNvGraphicFramePr>
            <p:nvPr>
              <p:extLst/>
            </p:nvPr>
          </p:nvGraphicFramePr>
          <p:xfrm>
            <a:off x="909953" y="5341481"/>
            <a:ext cx="2286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6" name="Chart 25"/>
            <p:cNvGraphicFramePr>
              <a:graphicFrameLocks/>
            </p:cNvGraphicFramePr>
            <p:nvPr>
              <p:extLst/>
            </p:nvPr>
          </p:nvGraphicFramePr>
          <p:xfrm>
            <a:off x="3337896" y="5341481"/>
            <a:ext cx="2286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1709754" y="7170281"/>
              <a:ext cx="1103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66279" y="7170281"/>
              <a:ext cx="1103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M-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/>
          </p:nvGraphicFramePr>
          <p:xfrm>
            <a:off x="3489417" y="664516"/>
            <a:ext cx="2020824" cy="15212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4" name="Prism 7" r:id="rId5" imgW="4109598" imgH="3093510" progId="Prism7.Document">
                    <p:embed/>
                  </p:oleObj>
                </mc:Choice>
                <mc:Fallback>
                  <p:oleObj name="Prism 7" r:id="rId5" imgW="4109598" imgH="309351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489417" y="664516"/>
                          <a:ext cx="2020824" cy="152127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/>
          </p:nvGraphicFramePr>
          <p:xfrm>
            <a:off x="3489417" y="2151316"/>
            <a:ext cx="2020824" cy="15212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5" name="Prism 7" r:id="rId7" imgW="4109598" imgH="3093510" progId="Prism7.Document">
                    <p:embed/>
                  </p:oleObj>
                </mc:Choice>
                <mc:Fallback>
                  <p:oleObj name="Prism 7" r:id="rId7" imgW="4109598" imgH="309351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489417" y="2151316"/>
                          <a:ext cx="2020824" cy="152127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3197780"/>
                </p:ext>
              </p:extLst>
            </p:nvPr>
          </p:nvGraphicFramePr>
          <p:xfrm>
            <a:off x="3489417" y="3672592"/>
            <a:ext cx="2020824" cy="1661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6" name="Prism 7" r:id="rId9" imgW="4109598" imgH="3380040" progId="Prism7.Document">
                    <p:embed/>
                  </p:oleObj>
                </mc:Choice>
                <mc:Fallback>
                  <p:oleObj name="Prism 7" r:id="rId9" imgW="4109598" imgH="338004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489417" y="3672592"/>
                          <a:ext cx="2020824" cy="1661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/>
            <p:cNvGraphicFramePr>
              <a:graphicFrameLocks/>
            </p:cNvGraphicFramePr>
            <p:nvPr/>
          </p:nvGraphicFramePr>
          <p:xfrm>
            <a:off x="998984" y="585592"/>
            <a:ext cx="2020824" cy="1600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7" name="Prism 7" r:id="rId11" imgW="3597743" imgH="2977602" progId="Prism7.Document">
                    <p:embed/>
                  </p:oleObj>
                </mc:Choice>
                <mc:Fallback>
                  <p:oleObj name="Prism 7" r:id="rId11" imgW="3597743" imgH="2977602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998984" y="585592"/>
                          <a:ext cx="2020824" cy="1600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/>
            <p:cNvGraphicFramePr>
              <a:graphicFrameLocks/>
            </p:cNvGraphicFramePr>
            <p:nvPr/>
          </p:nvGraphicFramePr>
          <p:xfrm>
            <a:off x="999323" y="2072031"/>
            <a:ext cx="2020888" cy="1600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8" name="Prism 7" r:id="rId13" imgW="3597743" imgH="2977602" progId="Prism7.Document">
                    <p:embed/>
                  </p:oleObj>
                </mc:Choice>
                <mc:Fallback>
                  <p:oleObj name="Prism 7" r:id="rId13" imgW="3597743" imgH="2977602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999323" y="2072031"/>
                          <a:ext cx="2020888" cy="1600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ct 29"/>
            <p:cNvGraphicFramePr>
              <a:graphicFrameLocks/>
            </p:cNvGraphicFramePr>
            <p:nvPr/>
          </p:nvGraphicFramePr>
          <p:xfrm>
            <a:off x="1001617" y="3688494"/>
            <a:ext cx="2020824" cy="1600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99" name="Prism 7" r:id="rId15" imgW="3597743" imgH="3232095" progId="Prism7.Document">
                    <p:embed/>
                  </p:oleObj>
                </mc:Choice>
                <mc:Fallback>
                  <p:oleObj name="Prism 7" r:id="rId15" imgW="3597743" imgH="3232095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001617" y="3688494"/>
                          <a:ext cx="2020824" cy="1600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727251" y="304766"/>
              <a:ext cx="543465" cy="379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15051" y="304766"/>
              <a:ext cx="543465" cy="379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27251" y="4985512"/>
              <a:ext cx="543465" cy="379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280037" y="8774668"/>
            <a:ext cx="2473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284157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97408" y="409075"/>
            <a:ext cx="5559552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levated intracellular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evel does not affect proliferation or viability of ECs. </a:t>
            </a:r>
          </a:p>
          <a:p>
            <a:pPr algn="just">
              <a:lnSpc>
                <a:spcPct val="20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HUVECs were cultured in 96-well plates for 24 hours and treated with DMSO (control)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BM-X, or 8Br-cAMP for additional 48 hours. MTT assays were conducted to assess cell proliferation, and results were obtained by measuring the absorbance at 570 nm in quadruplicate for each condition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Similarly, cell viability was determin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Tit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Fluor™ Cell Viability Assay by measuring fluorescence generated by live cells in quadruplicate for each condition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udent’s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test, *p&lt;0.0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ns: not significant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intracellula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evels were determined by ELISA at different time points after treatment of HUVECs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r IBM-X. Results are shown as mean ± SEM of triplicated wells.</a:t>
            </a:r>
          </a:p>
        </p:txBody>
      </p:sp>
    </p:spTree>
    <p:extLst>
      <p:ext uri="{BB962C8B-B14F-4D97-AF65-F5344CB8AC3E}">
        <p14:creationId xmlns:p14="http://schemas.microsoft.com/office/powerpoint/2010/main" val="2903331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065</TotalTime>
  <Words>166</Words>
  <Application>Microsoft Office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e perrot</dc:creator>
  <cp:lastModifiedBy>Carole Perrot</cp:lastModifiedBy>
  <cp:revision>707</cp:revision>
  <cp:lastPrinted>2018-04-05T19:47:36Z</cp:lastPrinted>
  <dcterms:created xsi:type="dcterms:W3CDTF">2016-03-11T17:24:59Z</dcterms:created>
  <dcterms:modified xsi:type="dcterms:W3CDTF">2018-04-19T14:20:14Z</dcterms:modified>
</cp:coreProperties>
</file>